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E6ABBC-B235-4E40-8D6B-52FCC8A6A3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3D6202-2690-41E9-92B2-BF024357D9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8E649A-4CAF-4E45-AF88-1417408AC9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6C2FA-3217-4DF7-8894-3AF25DAFB4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CD68B6-8D41-4A5E-A2F5-586247F95A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ECE8AD-D5F9-4BBF-BAE3-71281A90CA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49B747-89EF-4DD1-98F1-5F036C1D0F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AEFF84-71B4-4342-9F46-1E563BCA26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D02DC9-3CD9-422A-B512-3F0F905EB9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886EAA-355E-437F-AE9C-8B79F30C45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CFB72-8B3C-4CE9-BC03-DAD2D70E28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132BB-4230-4FE0-8BF3-BCFE9FD35E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D51588-7FB6-423C-B768-76251012C97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520" y="1293840"/>
            <a:ext cx="5382720" cy="7851600"/>
            <a:chOff x="2520" y="1293840"/>
            <a:chExt cx="5382720" cy="7851600"/>
          </a:xfrm>
        </p:grpSpPr>
        <p:sp>
          <p:nvSpPr>
            <p:cNvPr id="42" name=""/>
            <p:cNvSpPr/>
            <p:nvPr/>
          </p:nvSpPr>
          <p:spPr>
            <a:xfrm>
              <a:off x="2520" y="8777160"/>
              <a:ext cx="953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Arial"/>
                </a:rPr>
                <a:t>Suppl.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4352760" y="6934320"/>
              <a:ext cx="971640" cy="237960"/>
              <a:chOff x="4352760" y="6934320"/>
              <a:chExt cx="971640" cy="237960"/>
            </a:xfrm>
          </p:grpSpPr>
          <p:sp>
            <p:nvSpPr>
              <p:cNvPr id="44" name=""/>
              <p:cNvSpPr/>
              <p:nvPr/>
            </p:nvSpPr>
            <p:spPr>
              <a:xfrm>
                <a:off x="4444920" y="7016760"/>
                <a:ext cx="138240" cy="77760"/>
              </a:xfrm>
              <a:prstGeom prst="rect">
                <a:avLst/>
              </a:prstGeom>
              <a:solidFill>
                <a:srgbClr val="0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4606200" y="6997680"/>
                <a:ext cx="210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FP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5115960" y="7004160"/>
                <a:ext cx="20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D.N.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4916520" y="7021440"/>
                <a:ext cx="138240" cy="7776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4352760" y="6934320"/>
                <a:ext cx="971640" cy="2379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9" name=""/>
            <p:cNvSpPr/>
            <p:nvPr/>
          </p:nvSpPr>
          <p:spPr>
            <a:xfrm>
              <a:off x="4739040" y="3062160"/>
              <a:ext cx="38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F-Y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738680" y="4062240"/>
              <a:ext cx="57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3K4me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738320" y="5929200"/>
              <a:ext cx="63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3K9,14a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738320" y="5091120"/>
              <a:ext cx="646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3K79me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3" name=""/>
            <p:cNvGrpSpPr/>
            <p:nvPr/>
          </p:nvGrpSpPr>
          <p:grpSpPr>
            <a:xfrm>
              <a:off x="1695600" y="2890800"/>
              <a:ext cx="2782800" cy="732960"/>
              <a:chOff x="1695600" y="2890800"/>
              <a:chExt cx="2782800" cy="732960"/>
            </a:xfrm>
          </p:grpSpPr>
          <p:sp>
            <p:nvSpPr>
              <p:cNvPr id="54" name=""/>
              <p:cNvSpPr/>
              <p:nvPr/>
            </p:nvSpPr>
            <p:spPr>
              <a:xfrm>
                <a:off x="1959120" y="3389040"/>
                <a:ext cx="79200" cy="19656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220840" y="3349440"/>
                <a:ext cx="73080" cy="23616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2476440" y="3428640"/>
                <a:ext cx="81000" cy="15696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2739960" y="3301560"/>
                <a:ext cx="73080" cy="28404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2992320" y="3436560"/>
                <a:ext cx="73080" cy="14904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214800" y="3341520"/>
                <a:ext cx="73080" cy="24408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470400" y="3468240"/>
                <a:ext cx="81000" cy="11736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3733920" y="3436560"/>
                <a:ext cx="73080" cy="14904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3989520" y="3460320"/>
                <a:ext cx="81000" cy="12528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038320" y="3508200"/>
                <a:ext cx="73080" cy="7740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2293920" y="3516120"/>
                <a:ext cx="73080" cy="6948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2557440" y="3531960"/>
                <a:ext cx="73080" cy="5364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813040" y="3554280"/>
                <a:ext cx="73080" cy="3132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3065400" y="3524040"/>
                <a:ext cx="73080" cy="6156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3287880" y="3524040"/>
                <a:ext cx="72720" cy="6156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3551400" y="3538080"/>
                <a:ext cx="72720" cy="4752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3807000" y="3570120"/>
                <a:ext cx="72720" cy="1548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4070520" y="3570120"/>
                <a:ext cx="72720" cy="1548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1908000" y="2946240"/>
                <a:ext cx="1800" cy="639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1886040" y="3585960"/>
                <a:ext cx="219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1886040" y="3460320"/>
                <a:ext cx="219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886040" y="3333600"/>
                <a:ext cx="219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886040" y="3198600"/>
                <a:ext cx="219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1886040" y="3072960"/>
                <a:ext cx="219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886040" y="2946240"/>
                <a:ext cx="219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1908000" y="3585960"/>
                <a:ext cx="256860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flipV="1">
                <a:off x="1908000" y="3585600"/>
                <a:ext cx="1800" cy="2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flipV="1">
                <a:off x="2170080" y="3585600"/>
                <a:ext cx="1800" cy="2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flipV="1">
                <a:off x="2425680" y="3585600"/>
                <a:ext cx="1440" cy="2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 flipV="1">
                <a:off x="2689200" y="3585600"/>
                <a:ext cx="1440" cy="2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V="1">
                <a:off x="2941560" y="3585600"/>
                <a:ext cx="1800" cy="2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 flipV="1">
                <a:off x="3197160" y="3585600"/>
                <a:ext cx="1800" cy="2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 flipV="1">
                <a:off x="3419640" y="3585600"/>
                <a:ext cx="1440" cy="2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 flipV="1">
                <a:off x="3683160" y="3585600"/>
                <a:ext cx="1440" cy="2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 flipV="1">
                <a:off x="3938760" y="3585600"/>
                <a:ext cx="1440" cy="2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 flipV="1">
                <a:off x="4476600" y="3585600"/>
                <a:ext cx="1800" cy="2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1798200" y="35319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1746360" y="34048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1746360" y="32778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1746360" y="31446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9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1695600" y="30175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1695600" y="28908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5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4268880" y="3425400"/>
                <a:ext cx="81000" cy="15696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4349880" y="3558960"/>
                <a:ext cx="72720" cy="2340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 flipV="1">
                <a:off x="4218120" y="3582360"/>
                <a:ext cx="1440" cy="2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9" name=""/>
            <p:cNvSpPr/>
            <p:nvPr/>
          </p:nvSpPr>
          <p:spPr>
            <a:xfrm>
              <a:off x="1965240" y="3854520"/>
              <a:ext cx="79560" cy="64908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227320" y="3855960"/>
              <a:ext cx="66600" cy="6476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482920" y="4376880"/>
              <a:ext cx="81000" cy="12672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744640" y="4203720"/>
              <a:ext cx="81000" cy="29988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997360" y="4361040"/>
              <a:ext cx="79200" cy="14256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216240" y="4305240"/>
              <a:ext cx="81000" cy="19836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479760" y="4273560"/>
              <a:ext cx="79560" cy="2300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741840" y="4329000"/>
              <a:ext cx="73080" cy="17460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997440" y="4203720"/>
              <a:ext cx="81000" cy="29988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044800" y="4456080"/>
              <a:ext cx="73080" cy="4752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300400" y="4440240"/>
              <a:ext cx="73080" cy="6336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563920" y="4440240"/>
              <a:ext cx="73080" cy="6336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825640" y="4424400"/>
              <a:ext cx="73080" cy="7920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076560" y="4487760"/>
              <a:ext cx="73080" cy="1584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297240" y="4487760"/>
              <a:ext cx="73080" cy="1584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559320" y="4464000"/>
              <a:ext cx="72720" cy="3960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814920" y="4487760"/>
              <a:ext cx="72720" cy="1584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344840" y="4495680"/>
              <a:ext cx="73080" cy="792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913040" y="3848040"/>
              <a:ext cx="1440" cy="65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892160" y="4503600"/>
              <a:ext cx="20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892160" y="4368960"/>
              <a:ext cx="20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892160" y="4243320"/>
              <a:ext cx="20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892160" y="4108320"/>
              <a:ext cx="20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892160" y="3981600"/>
              <a:ext cx="20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892160" y="3848040"/>
              <a:ext cx="20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913040" y="4503600"/>
              <a:ext cx="2568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flipV="1">
              <a:off x="1913040" y="45032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 flipV="1">
              <a:off x="2176560" y="45032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2432160" y="45032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 flipV="1">
              <a:off x="2693880" y="4503240"/>
              <a:ext cx="180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flipV="1">
              <a:off x="2946240" y="4503240"/>
              <a:ext cx="180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 flipV="1">
              <a:off x="3208320" y="45032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flipV="1">
              <a:off x="3429000" y="45032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flipV="1">
              <a:off x="3691080" y="45032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3946680" y="45032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 flipV="1">
              <a:off x="4475160" y="45032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803240" y="4448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1752480" y="43131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752480" y="41878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752480" y="40528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701720" y="392760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701720" y="379260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4237200" y="4448160"/>
              <a:ext cx="72720" cy="554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4309920" y="4464000"/>
              <a:ext cx="73080" cy="3960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V="1">
              <a:off x="4186080" y="4503240"/>
              <a:ext cx="180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4" name=""/>
            <p:cNvGrpSpPr/>
            <p:nvPr/>
          </p:nvGrpSpPr>
          <p:grpSpPr>
            <a:xfrm>
              <a:off x="1701720" y="4618080"/>
              <a:ext cx="2813040" cy="739440"/>
              <a:chOff x="1701720" y="4618080"/>
              <a:chExt cx="2813040" cy="739440"/>
            </a:xfrm>
          </p:grpSpPr>
          <p:sp>
            <p:nvSpPr>
              <p:cNvPr id="145" name=""/>
              <p:cNvSpPr/>
              <p:nvPr/>
            </p:nvSpPr>
            <p:spPr>
              <a:xfrm>
                <a:off x="1965240" y="5202360"/>
                <a:ext cx="79560" cy="11916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2227320" y="5154840"/>
                <a:ext cx="73080" cy="16668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2482920" y="5234040"/>
                <a:ext cx="81000" cy="8748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2744640" y="5162760"/>
                <a:ext cx="81000" cy="15876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016080" y="5274000"/>
                <a:ext cx="79560" cy="4752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3273480" y="5186520"/>
                <a:ext cx="81000" cy="13500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3537000" y="5115240"/>
                <a:ext cx="79200" cy="20628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3798720" y="5218200"/>
                <a:ext cx="73080" cy="10332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4054320" y="5194440"/>
                <a:ext cx="81000" cy="12708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2044800" y="5305680"/>
                <a:ext cx="72720" cy="1584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2300400" y="5274000"/>
                <a:ext cx="72720" cy="4752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2563920" y="5281920"/>
                <a:ext cx="72720" cy="3960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2825640" y="5265720"/>
                <a:ext cx="73080" cy="5580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3095640" y="5305680"/>
                <a:ext cx="73080" cy="1584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3354480" y="5297760"/>
                <a:ext cx="72720" cy="2376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3616200" y="5305680"/>
                <a:ext cx="73080" cy="1584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3871800" y="5313600"/>
                <a:ext cx="73080" cy="792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1913040" y="4673880"/>
                <a:ext cx="1440" cy="64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1892160" y="5321520"/>
                <a:ext cx="208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1892160" y="5194440"/>
                <a:ext cx="208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1892160" y="5061240"/>
                <a:ext cx="208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1892160" y="4934160"/>
                <a:ext cx="208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1892160" y="4799160"/>
                <a:ext cx="208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1892160" y="4673880"/>
                <a:ext cx="208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1913040" y="5321520"/>
                <a:ext cx="25938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 flipV="1">
                <a:off x="1913040" y="532152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 flipV="1">
                <a:off x="2176560" y="532152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 flipV="1">
                <a:off x="2432160" y="532152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 flipV="1">
                <a:off x="2693880" y="5321520"/>
                <a:ext cx="180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 flipV="1">
                <a:off x="2965320" y="5321520"/>
                <a:ext cx="180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 flipV="1">
                <a:off x="3227400" y="532152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 flipV="1">
                <a:off x="3222720" y="532152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 flipV="1">
                <a:off x="3486240" y="532152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 flipV="1">
                <a:off x="3747960" y="5321520"/>
                <a:ext cx="180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 flipV="1">
                <a:off x="4003560" y="5321520"/>
                <a:ext cx="180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 flipV="1">
                <a:off x="4513320" y="532152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1802880" y="526572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1752480" y="51390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1752480" y="50054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1752480" y="48783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9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1701720" y="474516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1701720" y="461808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5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4290840" y="5254920"/>
                <a:ext cx="73080" cy="6336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4363920" y="5310360"/>
                <a:ext cx="73080" cy="792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 flipV="1">
                <a:off x="4240080" y="5318280"/>
                <a:ext cx="180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0" name=""/>
            <p:cNvSpPr/>
            <p:nvPr/>
          </p:nvSpPr>
          <p:spPr>
            <a:xfrm>
              <a:off x="1968480" y="6021360"/>
              <a:ext cx="79560" cy="2840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2230560" y="5653080"/>
              <a:ext cx="66600" cy="65232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2486160" y="6242040"/>
              <a:ext cx="81000" cy="6336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2747880" y="6154560"/>
              <a:ext cx="81000" cy="1508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3019320" y="6194520"/>
              <a:ext cx="79560" cy="11088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3257640" y="6249960"/>
              <a:ext cx="81000" cy="554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3521160" y="6114960"/>
              <a:ext cx="79200" cy="1904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3782880" y="6162840"/>
              <a:ext cx="73080" cy="14256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4038480" y="6154560"/>
              <a:ext cx="81000" cy="1508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2048040" y="5661000"/>
              <a:ext cx="72720" cy="64440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2303640" y="5653080"/>
              <a:ext cx="60120" cy="65232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2567160" y="6186600"/>
              <a:ext cx="72720" cy="11880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2828880" y="5894280"/>
              <a:ext cx="73080" cy="41112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3098880" y="6060960"/>
              <a:ext cx="73080" cy="24444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3338640" y="6178680"/>
              <a:ext cx="72720" cy="12672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3600360" y="6021360"/>
              <a:ext cx="73080" cy="28404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3855960" y="6146640"/>
              <a:ext cx="73080" cy="15876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119480" y="6091200"/>
              <a:ext cx="73080" cy="21420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1916280" y="5657760"/>
              <a:ext cx="1440" cy="64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1895400" y="6305400"/>
              <a:ext cx="20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1895400" y="6178680"/>
              <a:ext cx="20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1895400" y="6045120"/>
              <a:ext cx="20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1895400" y="5918040"/>
              <a:ext cx="20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1895400" y="5783400"/>
              <a:ext cx="20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1895400" y="5657760"/>
              <a:ext cx="20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1916280" y="6305400"/>
              <a:ext cx="25938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 flipV="1">
              <a:off x="1916280" y="63050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flipV="1">
              <a:off x="2179800" y="63050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 flipV="1">
              <a:off x="2435400" y="63050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flipV="1">
              <a:off x="2697120" y="6305040"/>
              <a:ext cx="180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 flipV="1">
              <a:off x="2968560" y="6305040"/>
              <a:ext cx="180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flipV="1">
              <a:off x="3230640" y="63050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 flipV="1">
              <a:off x="3470400" y="63050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 flipV="1">
              <a:off x="3732120" y="6305040"/>
              <a:ext cx="180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 flipV="1">
              <a:off x="3987720" y="6305040"/>
              <a:ext cx="180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V="1">
              <a:off x="4510080" y="63050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1806120" y="6249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1755720" y="61228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1755720" y="59896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1755720" y="58626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1704960" y="572940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1704960" y="56023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2166840" y="5870520"/>
              <a:ext cx="55800" cy="130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4297320" y="6249960"/>
              <a:ext cx="73080" cy="554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4370400" y="6265800"/>
              <a:ext cx="73080" cy="3960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 flipV="1">
              <a:off x="4246560" y="630504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 rot="18900000">
              <a:off x="1979280" y="2660400"/>
              <a:ext cx="457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NDUFV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 rot="18900000">
              <a:off x="2237040" y="2598480"/>
              <a:ext cx="63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APOBEC3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 rot="18900000">
              <a:off x="2549520" y="2736360"/>
              <a:ext cx="2415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CK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 rot="18900000">
              <a:off x="2805120" y="2712600"/>
              <a:ext cx="31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CDC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rot="18900000">
              <a:off x="3013200" y="2628360"/>
              <a:ext cx="546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HERPUD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rot="18900000">
              <a:off x="3286440" y="2708280"/>
              <a:ext cx="323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CN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rot="18900000">
              <a:off x="3537000" y="2712600"/>
              <a:ext cx="31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TC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rot="18900000">
              <a:off x="3767760" y="2676240"/>
              <a:ext cx="4122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ORC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rot="18900000">
              <a:off x="4011480" y="2628360"/>
              <a:ext cx="546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TMEM50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rot="18900000">
              <a:off x="4327920" y="2706480"/>
              <a:ext cx="329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CHO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rot="16200000">
              <a:off x="1236240" y="3147120"/>
              <a:ext cx="679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Fol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enrichmen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rot="16200000">
              <a:off x="1125720" y="4839840"/>
              <a:ext cx="90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Fold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enrichmen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rot="16200000">
              <a:off x="1248480" y="4024440"/>
              <a:ext cx="654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Fold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enrichmen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 rot="16200000">
              <a:off x="1236240" y="5842080"/>
              <a:ext cx="679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Fol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enrichmen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1488960" y="1293840"/>
              <a:ext cx="372132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upplementary 1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aw data of the experiments of Fig. 2, before normalization for the total H3 recovery.</a:t>
              </a: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06T14:54:03Z</dcterms:created>
  <dc:creator>raffaella</dc:creator>
  <dc:description/>
  <dc:language>en-US</dc:language>
  <cp:lastModifiedBy>ROBERTO</cp:lastModifiedBy>
  <dcterms:modified xsi:type="dcterms:W3CDTF">2008-02-07T17:16:06Z</dcterms:modified>
  <cp:revision>14</cp:revision>
  <dc:subject/>
  <dc:title>Diapositiva 1</dc:title>
</cp:coreProperties>
</file>